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5.png" ContentType="image/png"/>
  <Override PartName="/ppt/media/image2.jpeg" ContentType="image/jpeg"/>
  <Override PartName="/ppt/media/image3.jpeg" ContentType="image/jpeg"/>
  <Override PartName="/ppt/media/image4.jpeg" ContentType="image/jpeg"/>
  <Override PartName="/ppt/media/image6.jpeg" ContentType="image/jpeg"/>
  <Override PartName="/ppt/media/image7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AC9279-B35D-49BF-A657-E61FA9B8652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5FB68C-FAB3-460F-BE47-50ED4DA5805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895AC6-09B2-4BC5-B065-59BFF2214D5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E2E76A-96B6-407A-AF5C-8EB83042E9B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282F1D-5F6D-4FFB-810B-17AF8195BC6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8FAAA3-5714-4C13-93A6-7B45F665C1A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0BE793-1B54-488B-BE77-282ED42AF26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5757AB-A9BC-4C16-A964-34C73504CC7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DBCF3E-162E-41C7-815D-9E7F6CD6D92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CD16C2-58C4-4CA4-A904-4626CD4A3D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A23291-E4DF-4206-BB66-2F5E7ADAB56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AB4359-2306-493A-BA5F-6F8450F3B6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7265F23-0146-4384-9136-3364A8DCC643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pn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组合 45"/>
          <p:cNvGrpSpPr/>
          <p:nvPr/>
        </p:nvGrpSpPr>
        <p:grpSpPr>
          <a:xfrm>
            <a:off x="644400" y="657360"/>
            <a:ext cx="5259600" cy="2609640"/>
            <a:chOff x="644400" y="657360"/>
            <a:chExt cx="5259600" cy="2609640"/>
          </a:xfrm>
        </p:grpSpPr>
        <p:grpSp>
          <p:nvGrpSpPr>
            <p:cNvPr id="42" name="组合 1"/>
            <p:cNvGrpSpPr/>
            <p:nvPr/>
          </p:nvGrpSpPr>
          <p:grpSpPr>
            <a:xfrm>
              <a:off x="3274560" y="849960"/>
              <a:ext cx="2629440" cy="2402640"/>
              <a:chOff x="3274560" y="849960"/>
              <a:chExt cx="2629440" cy="2402640"/>
            </a:xfrm>
          </p:grpSpPr>
          <p:grpSp>
            <p:nvGrpSpPr>
              <p:cNvPr id="43" name="组合 2"/>
              <p:cNvGrpSpPr/>
              <p:nvPr/>
            </p:nvGrpSpPr>
            <p:grpSpPr>
              <a:xfrm>
                <a:off x="3274560" y="849960"/>
                <a:ext cx="2174040" cy="2402640"/>
                <a:chOff x="3274560" y="849960"/>
                <a:chExt cx="2174040" cy="2402640"/>
              </a:xfrm>
            </p:grpSpPr>
            <p:pic>
              <p:nvPicPr>
                <p:cNvPr id="44" name="Picture 3" descr="F:\LAB123\Data\wb\201502\201505\20150513-RIP3-2.jpg"/>
                <p:cNvPicPr/>
                <p:nvPr/>
              </p:nvPicPr>
              <p:blipFill>
                <a:blip r:embed="rId1"/>
                <a:srcRect l="19964" t="20273" r="45489" b="46617"/>
                <a:stretch/>
              </p:blipFill>
              <p:spPr>
                <a:xfrm>
                  <a:off x="4004280" y="2008800"/>
                  <a:ext cx="1440360" cy="57780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45" name="Picture 5" descr="F:\LAB123\Data\wb\201502\201505\20150513-GAPDH-2.jpg"/>
                <p:cNvPicPr/>
                <p:nvPr/>
              </p:nvPicPr>
              <p:blipFill>
                <a:blip r:embed="rId2"/>
                <a:srcRect l="19424" t="44947" r="45049" b="27551"/>
                <a:stretch/>
              </p:blipFill>
              <p:spPr>
                <a:xfrm>
                  <a:off x="4008240" y="2637360"/>
                  <a:ext cx="1440360" cy="6152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46" name="TextBox 8"/>
                <p:cNvSpPr/>
                <p:nvPr/>
              </p:nvSpPr>
              <p:spPr>
                <a:xfrm>
                  <a:off x="3422160" y="1024920"/>
                  <a:ext cx="40176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Arial"/>
                      <a:ea typeface="Arial Unicode MS"/>
                    </a:rPr>
                    <a:t>b</a:t>
                  </a:r>
                  <a:endParaRPr b="0" lang="en-US" sz="1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7" name="TextBox 9"/>
                <p:cNvSpPr/>
                <p:nvPr/>
              </p:nvSpPr>
              <p:spPr>
                <a:xfrm rot="10800000">
                  <a:off x="4364280" y="1269360"/>
                  <a:ext cx="332640" cy="741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 vert="eaVer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Dnmt1-1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8" name="TextBox 10"/>
                <p:cNvSpPr/>
                <p:nvPr/>
              </p:nvSpPr>
              <p:spPr>
                <a:xfrm rot="10800000">
                  <a:off x="4004280" y="1269360"/>
                  <a:ext cx="332640" cy="741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 vert="eaVer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control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9" name="TextBox 11"/>
                <p:cNvSpPr/>
                <p:nvPr/>
              </p:nvSpPr>
              <p:spPr>
                <a:xfrm rot="10800000">
                  <a:off x="4738320" y="1269360"/>
                  <a:ext cx="332640" cy="741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 vert="eaVer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Dnmt1-2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0" name="TextBox 12"/>
                <p:cNvSpPr/>
                <p:nvPr/>
              </p:nvSpPr>
              <p:spPr>
                <a:xfrm>
                  <a:off x="3778920" y="912600"/>
                  <a:ext cx="1620360" cy="4590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RKO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Dnmt1-shRNA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1" name="直接连接符 13"/>
                <p:cNvSpPr/>
                <p:nvPr/>
              </p:nvSpPr>
              <p:spPr>
                <a:xfrm>
                  <a:off x="4094280" y="1362600"/>
                  <a:ext cx="855000" cy="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2" name="TextBox 14"/>
                <p:cNvSpPr/>
                <p:nvPr/>
              </p:nvSpPr>
              <p:spPr>
                <a:xfrm rot="10800000">
                  <a:off x="5098320" y="849960"/>
                  <a:ext cx="332640" cy="1163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 vert="eaVer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UHRF1-shRNA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3" name="TextBox 15"/>
                <p:cNvSpPr/>
                <p:nvPr/>
              </p:nvSpPr>
              <p:spPr>
                <a:xfrm>
                  <a:off x="3274560" y="2810160"/>
                  <a:ext cx="7786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GAPDH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4" name="TextBox 16"/>
                <p:cNvSpPr/>
                <p:nvPr/>
              </p:nvSpPr>
              <p:spPr>
                <a:xfrm>
                  <a:off x="3467880" y="2128320"/>
                  <a:ext cx="5400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RIP3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55" name="TextBox 187"/>
              <p:cNvSpPr/>
              <p:nvPr/>
            </p:nvSpPr>
            <p:spPr>
              <a:xfrm>
                <a:off x="5380200" y="1723320"/>
                <a:ext cx="4917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bp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" name="TextBox 46"/>
              <p:cNvSpPr/>
              <p:nvPr/>
            </p:nvSpPr>
            <p:spPr>
              <a:xfrm>
                <a:off x="5299920" y="2841480"/>
                <a:ext cx="527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50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7" name="TextBox 46"/>
              <p:cNvSpPr/>
              <p:nvPr/>
            </p:nvSpPr>
            <p:spPr>
              <a:xfrm>
                <a:off x="5323320" y="2121480"/>
                <a:ext cx="580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500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58" name="组合 17"/>
            <p:cNvGrpSpPr/>
            <p:nvPr/>
          </p:nvGrpSpPr>
          <p:grpSpPr>
            <a:xfrm>
              <a:off x="644400" y="657360"/>
              <a:ext cx="2304000" cy="2609640"/>
              <a:chOff x="644400" y="657360"/>
              <a:chExt cx="2304000" cy="2609640"/>
            </a:xfrm>
          </p:grpSpPr>
          <p:grpSp>
            <p:nvGrpSpPr>
              <p:cNvPr id="59" name="组合 18"/>
              <p:cNvGrpSpPr/>
              <p:nvPr/>
            </p:nvGrpSpPr>
            <p:grpSpPr>
              <a:xfrm>
                <a:off x="644400" y="657360"/>
                <a:ext cx="2263680" cy="2609640"/>
                <a:chOff x="644400" y="657360"/>
                <a:chExt cx="2263680" cy="2609640"/>
              </a:xfrm>
            </p:grpSpPr>
            <p:grpSp>
              <p:nvGrpSpPr>
                <p:cNvPr id="60" name="组合 23"/>
                <p:cNvGrpSpPr/>
                <p:nvPr/>
              </p:nvGrpSpPr>
              <p:grpSpPr>
                <a:xfrm>
                  <a:off x="644400" y="657360"/>
                  <a:ext cx="2263680" cy="2609640"/>
                  <a:chOff x="644400" y="657360"/>
                  <a:chExt cx="2263680" cy="2609640"/>
                </a:xfrm>
              </p:grpSpPr>
              <p:grpSp>
                <p:nvGrpSpPr>
                  <p:cNvPr id="61" name="组合 25"/>
                  <p:cNvGrpSpPr/>
                  <p:nvPr/>
                </p:nvGrpSpPr>
                <p:grpSpPr>
                  <a:xfrm>
                    <a:off x="771840" y="713880"/>
                    <a:ext cx="2136240" cy="2553120"/>
                    <a:chOff x="771840" y="713880"/>
                    <a:chExt cx="2136240" cy="2553120"/>
                  </a:xfrm>
                </p:grpSpPr>
                <p:grpSp>
                  <p:nvGrpSpPr>
                    <p:cNvPr id="62" name="组合 27"/>
                    <p:cNvGrpSpPr/>
                    <p:nvPr/>
                  </p:nvGrpSpPr>
                  <p:grpSpPr>
                    <a:xfrm>
                      <a:off x="771840" y="713880"/>
                      <a:ext cx="2136240" cy="2553120"/>
                      <a:chOff x="771840" y="713880"/>
                      <a:chExt cx="2136240" cy="2553120"/>
                    </a:xfrm>
                  </p:grpSpPr>
                  <p:pic>
                    <p:nvPicPr>
                      <p:cNvPr id="63" name="Picture 7" descr="F:\LAB123\Data\wb\201502\201505\RKO-sigle kd-actin.jpg"/>
                      <p:cNvPicPr/>
                      <p:nvPr/>
                    </p:nvPicPr>
                    <p:blipFill>
                      <a:blip r:embed="rId3"/>
                      <a:srcRect l="30796" t="21685" r="41656" b="18097"/>
                      <a:stretch/>
                    </p:blipFill>
                    <p:spPr>
                      <a:xfrm>
                        <a:off x="1431000" y="2764800"/>
                        <a:ext cx="1080360" cy="502200"/>
                      </a:xfrm>
                      <a:prstGeom prst="rect">
                        <a:avLst/>
                      </a:prstGeom>
                      <a:ln w="12600">
                        <a:solidFill>
                          <a:srgbClr val="000000"/>
                        </a:solidFill>
                        <a:miter/>
                      </a:ln>
                    </p:spPr>
                  </p:pic>
                  <p:sp>
                    <p:nvSpPr>
                      <p:cNvPr id="64" name="TextBox 30"/>
                      <p:cNvSpPr/>
                      <p:nvPr/>
                    </p:nvSpPr>
                    <p:spPr>
                      <a:xfrm rot="10800000">
                        <a:off x="1823760" y="916920"/>
                        <a:ext cx="332640" cy="74124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 vert="eaVert">
                        <a:spAutoFit/>
                      </a:bodyPr>
                      <a:p>
                        <a:pPr>
                          <a:lnSpc>
                            <a:spcPct val="100000"/>
                          </a:lnSpc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1" lang="en-US" sz="1000" spc="-1" strike="noStrike">
                            <a:solidFill>
                              <a:srgbClr val="000000"/>
                            </a:solidFill>
                            <a:latin typeface="Arial"/>
                            <a:ea typeface="Arial"/>
                          </a:rPr>
                          <a:t>Dnmt1-1</a:t>
                        </a:r>
                        <a:endPara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65" name="TextBox 31"/>
                      <p:cNvSpPr/>
                      <p:nvPr/>
                    </p:nvSpPr>
                    <p:spPr>
                      <a:xfrm rot="10800000">
                        <a:off x="1463400" y="916920"/>
                        <a:ext cx="332640" cy="74124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 vert="eaVert">
                        <a:spAutoFit/>
                      </a:bodyPr>
                      <a:p>
                        <a:pPr>
                          <a:lnSpc>
                            <a:spcPct val="100000"/>
                          </a:lnSpc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1" lang="en-US" sz="1000" spc="-1" strike="noStrike">
                            <a:solidFill>
                              <a:srgbClr val="000000"/>
                            </a:solidFill>
                            <a:latin typeface="Arial"/>
                            <a:ea typeface="Arial"/>
                          </a:rPr>
                          <a:t>control</a:t>
                        </a:r>
                        <a:endPara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66" name="TextBox 32"/>
                      <p:cNvSpPr/>
                      <p:nvPr/>
                    </p:nvSpPr>
                    <p:spPr>
                      <a:xfrm rot="10800000">
                        <a:off x="2170080" y="916920"/>
                        <a:ext cx="332640" cy="74124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 vert="eaVert">
                        <a:spAutoFit/>
                      </a:bodyPr>
                      <a:p>
                        <a:pPr>
                          <a:lnSpc>
                            <a:spcPct val="100000"/>
                          </a:lnSpc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1" lang="en-US" sz="1000" spc="-1" strike="noStrike">
                            <a:solidFill>
                              <a:srgbClr val="000000"/>
                            </a:solidFill>
                            <a:latin typeface="Arial"/>
                            <a:ea typeface="Arial"/>
                          </a:rPr>
                          <a:t>Dnmt1-2</a:t>
                        </a:r>
                        <a:endPara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67" name="TextBox 33"/>
                      <p:cNvSpPr/>
                      <p:nvPr/>
                    </p:nvSpPr>
                    <p:spPr>
                      <a:xfrm>
                        <a:off x="771840" y="2855160"/>
                        <a:ext cx="927720" cy="27648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spAutoFit/>
                      </a:bodyPr>
                      <a:p>
                        <a:pPr>
                          <a:lnSpc>
                            <a:spcPct val="100000"/>
                          </a:lnSpc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1" lang="en-US" sz="1200" spc="-1" strike="noStrike">
                            <a:solidFill>
                              <a:srgbClr val="000000"/>
                            </a:solidFill>
                            <a:latin typeface="Times New Roman"/>
                            <a:ea typeface="Times New Roman"/>
                          </a:rPr>
                          <a:t>β-</a:t>
                        </a:r>
                        <a:r>
                          <a:rPr b="1" lang="en-US" sz="1200" spc="-1" strike="noStrike">
                            <a:solidFill>
                              <a:srgbClr val="000000"/>
                            </a:solidFill>
                            <a:latin typeface="Arial"/>
                            <a:ea typeface="Arial"/>
                          </a:rPr>
                          <a:t>actin</a:t>
                        </a:r>
                        <a:endPara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68" name="TextBox 34"/>
                      <p:cNvSpPr/>
                      <p:nvPr/>
                    </p:nvSpPr>
                    <p:spPr>
                      <a:xfrm>
                        <a:off x="937800" y="2312280"/>
                        <a:ext cx="756000" cy="27648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spAutoFit/>
                      </a:bodyPr>
                      <a:p>
                        <a:pPr>
                          <a:lnSpc>
                            <a:spcPct val="100000"/>
                          </a:lnSpc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1" lang="en-US" sz="1200" spc="-1" strike="noStrike">
                            <a:solidFill>
                              <a:srgbClr val="000000"/>
                            </a:solidFill>
                            <a:latin typeface="Arial"/>
                            <a:ea typeface="Arial"/>
                          </a:rPr>
                          <a:t>RIP3</a:t>
                        </a:r>
                        <a:endPara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pic>
                    <p:nvPicPr>
                      <p:cNvPr id="69" name="Picture 2" descr="F:\LAB123\Data\wb\201502\Dnmt1-shRNA-Dnmt1.jpg"/>
                      <p:cNvPicPr/>
                      <p:nvPr/>
                    </p:nvPicPr>
                    <p:blipFill>
                      <a:blip r:embed="rId4"/>
                      <a:srcRect l="58529" t="32811" r="13530" b="52551"/>
                      <a:stretch/>
                    </p:blipFill>
                    <p:spPr>
                      <a:xfrm>
                        <a:off x="1431000" y="1659960"/>
                        <a:ext cx="1080360" cy="403560"/>
                      </a:xfrm>
                      <a:prstGeom prst="rect">
                        <a:avLst/>
                      </a:prstGeom>
                      <a:ln w="12600">
                        <a:solidFill>
                          <a:srgbClr val="000000"/>
                        </a:solidFill>
                        <a:miter/>
                      </a:ln>
                    </p:spPr>
                  </p:pic>
                  <p:sp>
                    <p:nvSpPr>
                      <p:cNvPr id="70" name="TextBox 36"/>
                      <p:cNvSpPr/>
                      <p:nvPr/>
                    </p:nvSpPr>
                    <p:spPr>
                      <a:xfrm>
                        <a:off x="771840" y="1711080"/>
                        <a:ext cx="965880" cy="27648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spAutoFit/>
                      </a:bodyPr>
                      <a:p>
                        <a:pPr>
                          <a:lnSpc>
                            <a:spcPct val="100000"/>
                          </a:lnSpc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1" lang="en-US" sz="1200" spc="-1" strike="noStrike">
                            <a:solidFill>
                              <a:srgbClr val="000000"/>
                            </a:solidFill>
                            <a:latin typeface="Arial"/>
                            <a:ea typeface="Arial"/>
                          </a:rPr>
                          <a:t>Dnmt1</a:t>
                        </a:r>
                        <a:endPara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71" name="TextBox 37"/>
                      <p:cNvSpPr/>
                      <p:nvPr/>
                    </p:nvSpPr>
                    <p:spPr>
                      <a:xfrm>
                        <a:off x="1242360" y="713880"/>
                        <a:ext cx="1665720" cy="27648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spAutoFit/>
                      </a:bodyPr>
                      <a:p>
                        <a:pPr>
                          <a:lnSpc>
                            <a:spcPct val="100000"/>
                          </a:lnSpc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1" lang="en-US" sz="1200" spc="-1" strike="noStrike">
                            <a:solidFill>
                              <a:srgbClr val="000000"/>
                            </a:solidFill>
                            <a:latin typeface="Arial"/>
                            <a:ea typeface="Arial"/>
                          </a:rPr>
                          <a:t>RKO-Dnmt1-shRNA</a:t>
                        </a:r>
                        <a:endPara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72" name="直接连接符 38"/>
                      <p:cNvSpPr/>
                      <p:nvPr/>
                    </p:nvSpPr>
                    <p:spPr>
                      <a:xfrm>
                        <a:off x="1598400" y="1000080"/>
                        <a:ext cx="855360" cy="0"/>
                      </a:xfrm>
                      <a:prstGeom prst="line">
                        <a:avLst/>
                      </a:prstGeom>
                      <a:ln w="1908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6800" bIns="-46800" anchor="t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</p:grpSp>
                <p:sp>
                  <p:nvSpPr>
                    <p:cNvPr id="73" name="矩形 28"/>
                    <p:cNvSpPr/>
                    <p:nvPr/>
                  </p:nvSpPr>
                  <p:spPr>
                    <a:xfrm>
                      <a:off x="1139760" y="2215080"/>
                      <a:ext cx="229320" cy="2462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 Unicode MS"/>
                        </a:rPr>
                        <a:t>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  <p:sp>
                <p:nvSpPr>
                  <p:cNvPr id="74" name="TextBox 26"/>
                  <p:cNvSpPr/>
                  <p:nvPr/>
                </p:nvSpPr>
                <p:spPr>
                  <a:xfrm>
                    <a:off x="644400" y="657360"/>
                    <a:ext cx="407160" cy="337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6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a</a:t>
                    </a:r>
                    <a:endParaRPr b="0" lang="en-US" sz="16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pic>
              <p:nvPicPr>
                <p:cNvPr id="75" name="Picture 2" descr="C:\Users\yck\AppData\Roaming\Tencent\Users\282868583\QQ\WinTemp\RichOle\MMR~X}]ZMJEDB(F8CDOG7LV.png"/>
                <p:cNvPicPr/>
                <p:nvPr/>
              </p:nvPicPr>
              <p:blipFill>
                <a:blip r:embed="rId5"/>
                <a:srcRect l="23040" t="0" r="0" b="0"/>
                <a:stretch/>
              </p:blipFill>
              <p:spPr>
                <a:xfrm flipH="1">
                  <a:off x="1431000" y="2153520"/>
                  <a:ext cx="1080000" cy="540360"/>
                </a:xfrm>
                <a:prstGeom prst="rect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</p:pic>
          </p:grpSp>
          <p:sp>
            <p:nvSpPr>
              <p:cNvPr id="76" name="TextBox 187"/>
              <p:cNvSpPr/>
              <p:nvPr/>
            </p:nvSpPr>
            <p:spPr>
              <a:xfrm>
                <a:off x="2456640" y="1398600"/>
                <a:ext cx="4917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KD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7" name="TextBox 46"/>
              <p:cNvSpPr/>
              <p:nvPr/>
            </p:nvSpPr>
            <p:spPr>
              <a:xfrm>
                <a:off x="2444760" y="2876760"/>
                <a:ext cx="359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1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8" name="TextBox 46"/>
              <p:cNvSpPr/>
              <p:nvPr/>
            </p:nvSpPr>
            <p:spPr>
              <a:xfrm>
                <a:off x="2453400" y="2329560"/>
                <a:ext cx="359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53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9" name="TextBox 46"/>
              <p:cNvSpPr/>
              <p:nvPr/>
            </p:nvSpPr>
            <p:spPr>
              <a:xfrm>
                <a:off x="2399760" y="1699560"/>
                <a:ext cx="495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85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80" name="TextBox 43"/>
          <p:cNvSpPr/>
          <p:nvPr/>
        </p:nvSpPr>
        <p:spPr>
          <a:xfrm>
            <a:off x="414360" y="162000"/>
            <a:ext cx="98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Fig. S7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81" name="组合 44"/>
          <p:cNvGrpSpPr/>
          <p:nvPr/>
        </p:nvGrpSpPr>
        <p:grpSpPr>
          <a:xfrm>
            <a:off x="179280" y="3348000"/>
            <a:ext cx="6354720" cy="3610080"/>
            <a:chOff x="179280" y="3348000"/>
            <a:chExt cx="6354720" cy="3610080"/>
          </a:xfrm>
        </p:grpSpPr>
        <p:sp>
          <p:nvSpPr>
            <p:cNvPr id="82" name="TextBox 41"/>
            <p:cNvSpPr/>
            <p:nvPr/>
          </p:nvSpPr>
          <p:spPr>
            <a:xfrm>
              <a:off x="637920" y="3348000"/>
              <a:ext cx="4071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c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83" name="Picture 2" descr="C:\Users\yck\Desktop\Sp1-CDDis-Revision\ll2 dnmt expression.jpg"/>
            <p:cNvPicPr/>
            <p:nvPr/>
          </p:nvPicPr>
          <p:blipFill>
            <a:blip r:embed="rId6"/>
            <a:stretch/>
          </p:blipFill>
          <p:spPr>
            <a:xfrm>
              <a:off x="3578040" y="3677760"/>
              <a:ext cx="2955960" cy="3280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4" name="Picture 3" descr="C:\Users\yck\Desktop\Sp1-CDDis-Revision\ll2 uhrf1 expression.jpg"/>
            <p:cNvPicPr/>
            <p:nvPr/>
          </p:nvPicPr>
          <p:blipFill>
            <a:blip r:embed="rId7"/>
            <a:stretch/>
          </p:blipFill>
          <p:spPr>
            <a:xfrm>
              <a:off x="179280" y="3641400"/>
              <a:ext cx="2953080" cy="331668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85" name="矩形 46"/>
          <p:cNvSpPr/>
          <p:nvPr/>
        </p:nvSpPr>
        <p:spPr>
          <a:xfrm>
            <a:off x="142920" y="6851520"/>
            <a:ext cx="6624720" cy="11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7.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 Western blotting analysis of lysates from the indicated stable cell lines showing Dnmt1, RIP3 and β-actin levels. (b) Reverse transcription-PCR products from the indicate cells to detect the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ip3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RNA. </a:t>
            </a:r>
            <a:r>
              <a:rPr b="0" lang="pt-BR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c) RNAi of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UHRF1 and Dnmt1 in LL/2 cells. Real-time PCR products from the indicate cells to detect the UHRF1 and Dnmt1 mRNA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21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0-24T08:23:54Z</dcterms:created>
  <dc:creator>lj</dc:creator>
  <dc:description/>
  <dc:language>en-US</dc:language>
  <cp:lastModifiedBy>vidya.p</cp:lastModifiedBy>
  <cp:lastPrinted>2016-03-10T05:57:39Z</cp:lastPrinted>
  <dcterms:modified xsi:type="dcterms:W3CDTF">2017-09-28T04:25:28Z</dcterms:modified>
  <cp:revision>424</cp:revision>
  <dc:subject/>
  <dc:title>幻灯片 1</dc:title>
</cp:coreProperties>
</file>